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2FFA29-23DB-4876-807A-882869C4D20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6210F7-A8F7-47C6-AFCA-B2E9C4E33E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3D8D06-6FD3-466A-A1AC-9562F41C5CE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54D3CB-4D1A-4435-9994-E3420FC980B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D87191-F0BD-43D8-B5C6-087B755FF0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5A2C88-7B0F-4621-95F1-84F522DB14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CC88A6-7FFF-43DD-B8EC-4CC1413C8C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927578-4450-4BCB-B705-52C0FFC66D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5D02C6-6295-40F4-B75C-401F49DE90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56A1A4-37F4-45FD-8E81-3BC6F1C8C3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C85F37-78F0-4498-A60B-FDBF58680E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CE975E-F649-47E2-9650-93CDF255ED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B02A140-DD3E-404E-A865-394E91539B0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2"/>
          <p:cNvGraphicFramePr/>
          <p:nvPr/>
        </p:nvGraphicFramePr>
        <p:xfrm>
          <a:off x="5791320" y="3886200"/>
          <a:ext cx="3200400" cy="19526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791320" y="3886200"/>
                    <a:ext cx="3200400" cy="1952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Rectangle 4"/>
          <p:cNvSpPr/>
          <p:nvPr/>
        </p:nvSpPr>
        <p:spPr>
          <a:xfrm>
            <a:off x="1221120" y="594360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ectangle 6"/>
          <p:cNvSpPr/>
          <p:nvPr/>
        </p:nvSpPr>
        <p:spPr>
          <a:xfrm>
            <a:off x="4040280" y="601992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5" name="Object 4"/>
          <p:cNvGraphicFramePr/>
          <p:nvPr/>
        </p:nvGraphicFramePr>
        <p:xfrm>
          <a:off x="2819520" y="3809880"/>
          <a:ext cx="2447640" cy="21052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6" name="Object 4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819520" y="3809880"/>
                    <a:ext cx="2447640" cy="2105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7" name="Object 5"/>
          <p:cNvGraphicFramePr/>
          <p:nvPr/>
        </p:nvGraphicFramePr>
        <p:xfrm>
          <a:off x="228600" y="3809880"/>
          <a:ext cx="2352600" cy="210528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48" name="Object 5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228600" y="3809880"/>
                    <a:ext cx="2352600" cy="2105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9" name="Rectangle 9"/>
          <p:cNvSpPr/>
          <p:nvPr/>
        </p:nvSpPr>
        <p:spPr>
          <a:xfrm>
            <a:off x="7545600" y="601992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tangle 5"/>
          <p:cNvSpPr/>
          <p:nvPr/>
        </p:nvSpPr>
        <p:spPr>
          <a:xfrm>
            <a:off x="0" y="-69840"/>
            <a:ext cx="9144000" cy="3956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Compound 1 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(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raxerone) m.p. 240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°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; </a:t>
            </a:r>
            <a:r>
              <a:rPr b="0" lang="en-US" sz="1100" spc="-1" strike="noStrike" baseline="30000">
                <a:solidFill>
                  <a:srgbClr val="0c0d0d"/>
                </a:solidFill>
                <a:latin typeface="Times New Roman"/>
                <a:ea typeface="Times New Roman"/>
              </a:rPr>
              <a:t>1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H NMR data (400 MHz; CDCl</a:t>
            </a:r>
            <a:r>
              <a:rPr b="0" lang="en-US" sz="1100" spc="-1" strike="noStrike" baseline="-30000">
                <a:solidFill>
                  <a:srgbClr val="0c0d0d"/>
                </a:solidFill>
                <a:latin typeface="Times New Roman"/>
                <a:ea typeface="Times New Roman"/>
              </a:rPr>
              <a:t>3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):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δ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5.53 (1H, dd,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8.2, 3.2 Hz, H-15), 2.56 (1H, m, H-2b), 2.33 (1H, m, H-2a), 2.08 (1H, m, H-19b), 1.91 (1H, m, H-16b), 1.86 (1H, m, H-1b), 1.67 (1H, m, H-11b), 1.66 (1H, m, H-1a), 1.64 (1H, m, H-7b), 1.62 (1H, m, H-16a), 1.60 (1H, m, H-6b), 1.57 (1H, m, H-7a), 1.54 (1H, m, H-11a), 1.52 (1H, m, H-18), 1.49 (1H, m, H-6a), 1.37 (1H, m, H-19a), 1.34 (1H, m, H-12b), 1.32 (1H, m, H-22b), 1.30 (1H, m, H-22a), 1.27 (2H, m, H-21), 1.14 (3H, s, H-27), 1.09 (3H, s, H-23), 1.08 (3H, s, H-25), 1.07 (3H, s, H-24), 1.04 (1H, m, H-12a), 1.01 (1H, m, H-9), 0.96 (3H, s, H-29), 0.92 (3H, s, H-28), 0.91 (3H, s, H-30), 0.86 (1H, m, H-5), 0.83 (3H, s, H-26); </a:t>
            </a:r>
            <a:r>
              <a:rPr b="0" lang="en-US" sz="1100" spc="-1" strike="noStrike" baseline="30000">
                <a:solidFill>
                  <a:srgbClr val="0c0d0d"/>
                </a:solidFill>
                <a:latin typeface="Times New Roman"/>
                <a:ea typeface="Times New Roman"/>
              </a:rPr>
              <a:t>13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C NMR data (100 MHz; CDCl</a:t>
            </a:r>
            <a:r>
              <a:rPr b="0" lang="en-US" sz="1100" spc="-1" strike="noStrike" baseline="-30000">
                <a:solidFill>
                  <a:srgbClr val="0c0d0d"/>
                </a:solidFill>
                <a:latin typeface="Times New Roman"/>
                <a:ea typeface="Times New Roman"/>
              </a:rPr>
              <a:t>3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):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δ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 217.7 (C-3), 157.8 (C-14), 117.5 (C-15), 56.2 (C-5), 49.1 (C-18), 49.0 (C-9), 47.9 (C-4), 41.0 (C-19), 39.3 (C-8), 38.7 (C-1), 37.9 (C-13), 38.1 (C-10, C-17), 37.1 (C-16), 36.2 (C-12), 35.5 (C-7), 34.5 (C-2), 33.9 (C-21), 33.7 (C-29), 33.5 (C-22), 30.3 (C-26, C-28), 29.2 (C-20), 26.5 (C-23), 25.9 (C-27), 21.9 (C-24), 21.7 (C-30), 20.4 (C-6), 17.6 (C-11), 15.3 (C-25).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 ESIMS: 425 [M + H]</a:t>
            </a:r>
            <a:r>
              <a:rPr b="0" lang="en-US" sz="1100" spc="-1" strike="noStrike" baseline="30000">
                <a:solidFill>
                  <a:srgbClr val="0c0d0d"/>
                </a:solidFill>
                <a:latin typeface="Times New Roman"/>
                <a:ea typeface="Times New Roman"/>
              </a:rPr>
              <a:t>+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Compound 2 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(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raxerol)  m.p. 276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°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; </a:t>
            </a:r>
            <a:r>
              <a:rPr b="0" lang="en-US" sz="1100" spc="-1" strike="noStrike" baseline="30000">
                <a:solidFill>
                  <a:srgbClr val="0c0d0d"/>
                </a:solidFill>
                <a:latin typeface="Times New Roman"/>
                <a:ea typeface="Times New Roman"/>
              </a:rPr>
              <a:t>1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H NMR data (400 MHz; CDCl</a:t>
            </a:r>
            <a:r>
              <a:rPr b="0" lang="en-US" sz="1100" spc="-1" strike="noStrike" baseline="-30000">
                <a:solidFill>
                  <a:srgbClr val="0c0d0d"/>
                </a:solidFill>
                <a:latin typeface="Times New Roman"/>
                <a:ea typeface="Times New Roman"/>
              </a:rPr>
              <a:t>3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): δ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5.53 (1H, dd,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8.2, 3.4 Hz, H-15), 3.21 (1H, m, H-3), 2.05 (1H, m, H-19b), 1.91 (1H, m, H-16b), 1.67 (2H, m, H-2b, H-7b), 1.64 (2H, m, H-2a, H-16a), 1.62 (2H, m, H-1b, H-11b), 1.61 (1H, m, H-6b), 1.53 (1H, m, H-6a), 1.49 (1H, m, H-11a), 1.46 (1H, m, H-18), 1.45 (1H, m, H-7a), 1.38 (1H, m, H-22b), 1.35 (1H, m, H-19a), 1.31 (1H, m, H-12b), 1.25 (2H, m, H-21), 1.10 (3H, s, H-27), 1.02 (1H, m, H-12a), 0.99 (1H, m, H-22a), 0.97 (2H, m, H-1a, H-9), 0.96 (3H, s, H-23), 0.94 (3H, s, H-29), 0.92 (3H, s, H-24), 0.91 (6H, s, H-26, H-30), 0.88 (1H, m, H-5), 0.82 (3H, s, H-28), 0.80 (3H, s, H-25); </a:t>
            </a:r>
            <a:r>
              <a:rPr b="0" lang="en-US" sz="1100" spc="-1" strike="noStrike" baseline="30000">
                <a:solidFill>
                  <a:srgbClr val="0c0d0d"/>
                </a:solidFill>
                <a:latin typeface="Times New Roman"/>
                <a:ea typeface="Times New Roman"/>
              </a:rPr>
              <a:t>13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C NMR data (100 MHz; CDCl</a:t>
            </a:r>
            <a:r>
              <a:rPr b="0" lang="en-US" sz="1100" spc="-1" strike="noStrike" baseline="-30000">
                <a:solidFill>
                  <a:srgbClr val="0c0d0d"/>
                </a:solidFill>
                <a:latin typeface="Times New Roman"/>
                <a:ea typeface="Times New Roman"/>
              </a:rPr>
              <a:t>3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):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δ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158.1 (C-14), 116.9 (C-15), 79.1 (C-3), 55.5 (C-5), 49.3 (C-18), 48.7 (C-9), 41.3 (C-19), 39.0 (C-8), 38.7 (C-4), 38.0 (C-1), 37.7 (C-10, C-13), 37.6 (C-17), 36.7 (C-16), 35.8 (C-12), 35.1 (C-7), 33.7 (C-21), 33.4 (C-29), 33.2 (C-22), 30.1 (C-26), 29.9 (C-28), 28.8 (C-20), 28.0 (C-23), 27.1 (C-2), 25.9 (C-27), 21.3 (C-30), 18.8 (C-6), 17.5 (C-11), 15.5 (C-25), 15.4 (C-24). 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ESIMS: 427 [M + H]</a:t>
            </a:r>
            <a:r>
              <a:rPr b="0" lang="en-US" sz="1100" spc="-1" strike="noStrike" baseline="30000">
                <a:solidFill>
                  <a:srgbClr val="0c0d0d"/>
                </a:solidFill>
                <a:latin typeface="Times New Roman"/>
                <a:ea typeface="Times New Roman"/>
              </a:rPr>
              <a:t>+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Compound 3 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(Stigmasterol): m.p. 168 °C; </a:t>
            </a:r>
            <a:r>
              <a:rPr b="0" lang="en-US" sz="1100" spc="-1" strike="noStrike" baseline="30000">
                <a:solidFill>
                  <a:srgbClr val="0c0d0d"/>
                </a:solidFill>
                <a:latin typeface="Times New Roman"/>
                <a:ea typeface="Times New Roman"/>
              </a:rPr>
              <a:t>1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H NMR data (400 MHz; CDCl</a:t>
            </a:r>
            <a:r>
              <a:rPr b="0" lang="en-US" sz="1100" spc="-1" strike="noStrike" baseline="-30000">
                <a:solidFill>
                  <a:srgbClr val="0c0d0d"/>
                </a:solidFill>
                <a:latin typeface="Times New Roman"/>
                <a:ea typeface="Times New Roman"/>
              </a:rPr>
              <a:t>3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): δ 5.36 (1H, d, </a:t>
            </a:r>
            <a:r>
              <a:rPr b="0" i="1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J 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=4.8Hz, H-6), 5.14 (1H, dd, </a:t>
            </a:r>
            <a:r>
              <a:rPr b="0" i="1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J 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= 8.8, 14.2 Hz, H-22), 5.02 (1H, dd, J = 8.8, 14.8 Hz, H-23), 3.54 (1H, m, H-3), 1.03 (3H, s, H-19), 0.93 (3H, d, J = 6.4 Hz, H-21), 0.87 (3H, d, J = 7.2 Hz, H-26), 0.83 (3H, t, J = 7.4 Hz, H-29), 0.80 (3H, d, J = 8.4 Hz, H-27), 0.68 (3H, s, H-18); </a:t>
            </a:r>
            <a:r>
              <a:rPr b="0" lang="en-US" sz="1100" spc="-1" strike="noStrike" baseline="30000">
                <a:solidFill>
                  <a:srgbClr val="0c0d0d"/>
                </a:solidFill>
                <a:latin typeface="Times New Roman"/>
                <a:ea typeface="Times New Roman"/>
              </a:rPr>
              <a:t>13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C NMR data (100 MHz; CDCl</a:t>
            </a:r>
            <a:r>
              <a:rPr b="0" lang="en-US" sz="1100" spc="-1" strike="noStrike" baseline="-30000">
                <a:solidFill>
                  <a:srgbClr val="0c0d0d"/>
                </a:solidFill>
                <a:latin typeface="Times New Roman"/>
                <a:ea typeface="Times New Roman"/>
              </a:rPr>
              <a:t>3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): δ 140.8 (C-5), 138.3 (C-22), 129.3 (C-3), 121.7 (C-6), 71.8 (C-3), 56.8 (C-14), 56.1 (C-17), 51.2 (C-24), 50.2 (C-9), 45.8 (C-25), 42.3 (C-13), 40.7 (C-20), 39.8 (C-12), 37.4 (C-4), 37.3 (C-1), 36.5 (C-10), 32.0 (C-8), 31.8 (C-7), 29.2 (C-16), 28.2 (C-2), 25.4 (C-28), 24.4 (C-15), 21.2 (C-21), 21.1 (C-11), 19.8 (C-27), 19.4 (C-26), 19.0 (C-19), 12.0 (C-29), 11.9 (C-18); ESIMS: 413 [M + H]</a:t>
            </a:r>
            <a:r>
              <a:rPr b="0" lang="en-US" sz="1100" spc="-1" strike="noStrike" baseline="30000">
                <a:solidFill>
                  <a:srgbClr val="0c0d0d"/>
                </a:solidFill>
                <a:latin typeface="Times New Roman"/>
                <a:ea typeface="Times New Roman"/>
              </a:rPr>
              <a:t>+</a:t>
            </a:r>
            <a:r>
              <a:rPr b="0" lang="en-US" sz="1100" spc="-1" strike="noStrike">
                <a:solidFill>
                  <a:srgbClr val="0c0d0d"/>
                </a:solidFill>
                <a:latin typeface="Times New Roman"/>
                <a:ea typeface="Times New Roman"/>
              </a:rPr>
              <a:t>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ctangle 229"/>
          <p:cNvSpPr/>
          <p:nvPr/>
        </p:nvSpPr>
        <p:spPr>
          <a:xfrm>
            <a:off x="4148280" y="6396120"/>
            <a:ext cx="16365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 Figure 1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1" descr=""/>
          <p:cNvPicPr/>
          <p:nvPr/>
        </p:nvPicPr>
        <p:blipFill>
          <a:blip r:embed="rId1"/>
          <a:stretch/>
        </p:blipFill>
        <p:spPr>
          <a:xfrm>
            <a:off x="0" y="0"/>
            <a:ext cx="5465880" cy="640080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53" name=""/>
          <p:cNvGraphicFramePr/>
          <p:nvPr/>
        </p:nvGraphicFramePr>
        <p:xfrm>
          <a:off x="5791320" y="1447920"/>
          <a:ext cx="3039840" cy="1257120"/>
        </p:xfrm>
        <a:graphic>
          <a:graphicData uri="http://schemas.openxmlformats.org/drawingml/2006/table">
            <a:tbl>
              <a:tblPr/>
              <a:tblGrid>
                <a:gridCol w="819000"/>
                <a:gridCol w="849240"/>
                <a:gridCol w="1371600"/>
              </a:tblGrid>
              <a:tr h="2858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mpound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am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r>
                        <a:rPr b="0" lang="en-US" sz="11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12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AdvGulliv-R"/>
                        </a:rPr>
                        <a:t>Rut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AdvGulliv-R"/>
                        </a:rPr>
                        <a:t>3.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12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AdvGulliv-R"/>
                        </a:rPr>
                        <a:t>Myricet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12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AdvGulliv-R"/>
                        </a:rPr>
                        <a:t>Quercet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12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AdvGulliv-R"/>
                        </a:rPr>
                        <a:t>Apigen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4" name="Rectangle 3"/>
          <p:cNvSpPr/>
          <p:nvPr/>
        </p:nvSpPr>
        <p:spPr>
          <a:xfrm>
            <a:off x="4267080" y="3505320"/>
            <a:ext cx="76212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Arial"/>
              </a:rPr>
              <a:t>Extrac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Rectangle 2"/>
          <p:cNvSpPr/>
          <p:nvPr/>
        </p:nvSpPr>
        <p:spPr>
          <a:xfrm>
            <a:off x="3657600" y="380880"/>
            <a:ext cx="13716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Arial"/>
              </a:rPr>
              <a:t>Standard marker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Rectangle 229"/>
          <p:cNvSpPr/>
          <p:nvPr/>
        </p:nvSpPr>
        <p:spPr>
          <a:xfrm>
            <a:off x="4148280" y="6396120"/>
            <a:ext cx="16365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 Figure 2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Picture 1" descr=""/>
          <p:cNvPicPr/>
          <p:nvPr/>
        </p:nvPicPr>
        <p:blipFill>
          <a:blip r:embed="rId1"/>
          <a:stretch/>
        </p:blipFill>
        <p:spPr>
          <a:xfrm>
            <a:off x="609480" y="0"/>
            <a:ext cx="4670640" cy="640080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58" name=""/>
          <p:cNvGraphicFramePr/>
          <p:nvPr/>
        </p:nvGraphicFramePr>
        <p:xfrm>
          <a:off x="5257800" y="914400"/>
          <a:ext cx="3040200" cy="754200"/>
        </p:xfrm>
        <a:graphic>
          <a:graphicData uri="http://schemas.openxmlformats.org/drawingml/2006/table">
            <a:tbl>
              <a:tblPr/>
              <a:tblGrid>
                <a:gridCol w="819000"/>
                <a:gridCol w="1192320"/>
                <a:gridCol w="1028880"/>
              </a:tblGrid>
              <a:tr h="2858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mpound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am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r>
                        <a:rPr b="0" lang="en-US" sz="11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12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AdvGulliv-R"/>
                        </a:rPr>
                        <a:t>Gallic aci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AdvGulliv-R"/>
                        </a:rPr>
                        <a:t>4.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12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AdvGulliv-R"/>
                        </a:rPr>
                        <a:t>Chlorogenic aci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9" name="Rectangle 2"/>
          <p:cNvSpPr/>
          <p:nvPr/>
        </p:nvSpPr>
        <p:spPr>
          <a:xfrm>
            <a:off x="3048120" y="304920"/>
            <a:ext cx="13716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Arial"/>
              </a:rPr>
              <a:t>Standard marker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Rectangle 3"/>
          <p:cNvSpPr/>
          <p:nvPr/>
        </p:nvSpPr>
        <p:spPr>
          <a:xfrm>
            <a:off x="3657600" y="3505320"/>
            <a:ext cx="76212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Arial"/>
              </a:rPr>
              <a:t>Extrac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Rectangle 229"/>
          <p:cNvSpPr/>
          <p:nvPr/>
        </p:nvSpPr>
        <p:spPr>
          <a:xfrm>
            <a:off x="4148280" y="6396120"/>
            <a:ext cx="16365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 Figure 3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Saikat</dc:creator>
  <dc:description/>
  <dc:language>en-US</dc:language>
  <cp:lastModifiedBy>soeadmin</cp:lastModifiedBy>
  <dcterms:modified xsi:type="dcterms:W3CDTF">2014-12-04T06:11:23Z</dcterms:modified>
  <cp:revision>7</cp:revision>
  <dc:subject/>
  <dc:title>Slide 1</dc:title>
</cp:coreProperties>
</file>